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1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2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3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4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7" r:id="rId2"/>
    <p:sldId id="272" r:id="rId3"/>
    <p:sldId id="273" r:id="rId4"/>
    <p:sldId id="274" r:id="rId5"/>
    <p:sldId id="276" r:id="rId6"/>
    <p:sldId id="281" r:id="rId7"/>
    <p:sldId id="282" r:id="rId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6" d="100"/>
          <a:sy n="76" d="100"/>
        </p:scale>
        <p:origin x="13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85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ebastianms\Dropbox%20(Sebastian-BII)\aller\farrp\4180vsHuma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ebastianms\Dropbox%20(Sebastian-BII)\aller\farrp\farrp_celiac_pep_compo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Microsoft_Excel_Worksheet1.xlsx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package" Target="../embeddings/Microsoft_Excel_Worksheet2.xlsx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package" Target="../embeddings/Microsoft_Excel_Worksheet3.xlsx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ebastianms\Dropbox%20(Sebastian-BII)\aller\ms\revision\fold_distribution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ebastianms\Dropbox%20(Sebastian-BII)\aller\ms\revision\fold_distribution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alse positives in human proteome from</a:t>
            </a:r>
            <a:r>
              <a:rPr lang="en-US" baseline="0" dirty="0"/>
              <a:t> </a:t>
            </a:r>
            <a:r>
              <a:rPr lang="en-US" dirty="0"/>
              <a:t>hexamer rul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D$23:$D$26</c:f>
              <c:strCache>
                <c:ptCount val="4"/>
                <c:pt idx="0">
                  <c:v>2007 (AllergenOnline v7)</c:v>
                </c:pt>
                <c:pt idx="1">
                  <c:v>2013 (AllergenOnline v13)</c:v>
                </c:pt>
                <c:pt idx="2">
                  <c:v>2018 (AllergenOnline v18)</c:v>
                </c:pt>
                <c:pt idx="3">
                  <c:v>2018 (AllerCatPro v1.7)</c:v>
                </c:pt>
              </c:strCache>
            </c:strRef>
          </c:cat>
          <c:val>
            <c:numRef>
              <c:f>Sheet1!$K$23:$K$26</c:f>
              <c:numCache>
                <c:formatCode>General</c:formatCode>
                <c:ptCount val="4"/>
                <c:pt idx="0">
                  <c:v>67.347999999999999</c:v>
                </c:pt>
                <c:pt idx="1">
                  <c:v>75.661000000000001</c:v>
                </c:pt>
                <c:pt idx="2">
                  <c:v>80.278999999999996</c:v>
                </c:pt>
                <c:pt idx="3">
                  <c:v>89.254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D9-4B5B-A81A-7F2564D78C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0805824"/>
        <c:axId val="570807136"/>
      </c:barChart>
      <c:catAx>
        <c:axId val="5708058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70807136"/>
        <c:crosses val="autoZero"/>
        <c:auto val="1"/>
        <c:lblAlgn val="ctr"/>
        <c:lblOffset val="100"/>
        <c:noMultiLvlLbl val="0"/>
      </c:catAx>
      <c:valAx>
        <c:axId val="5708071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% human proteins with at least </a:t>
                </a:r>
              </a:p>
              <a:p>
                <a:pPr>
                  <a:defRPr sz="1200"/>
                </a:pPr>
                <a:r>
                  <a:rPr lang="en-US" sz="1200"/>
                  <a:t>1 hexamer shared with known allerge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708058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cap="none" spc="2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SG" sz="1800" dirty="0"/>
              <a:t>FARRP Celiac Peptide AA Composition </a:t>
            </a:r>
          </a:p>
          <a:p>
            <a:pPr>
              <a:defRPr sz="1800"/>
            </a:pPr>
            <a:r>
              <a:rPr lang="en-SG" sz="1800" dirty="0"/>
              <a:t>(log-odd score over background</a:t>
            </a:r>
            <a:r>
              <a:rPr lang="en-SG" sz="1800" baseline="0" dirty="0"/>
              <a:t> frequency)</a:t>
            </a:r>
            <a:endParaRPr lang="en-SG" sz="18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rotWithShape="1">
              <a:gsLst>
                <a:gs pos="0">
                  <a:schemeClr val="dk1">
                    <a:tint val="88500"/>
                    <a:lumMod val="110000"/>
                    <a:satMod val="105000"/>
                    <a:tint val="67000"/>
                  </a:schemeClr>
                </a:gs>
                <a:gs pos="50000">
                  <a:schemeClr val="dk1">
                    <a:tint val="88500"/>
                    <a:lumMod val="105000"/>
                    <a:satMod val="103000"/>
                    <a:tint val="73000"/>
                  </a:schemeClr>
                </a:gs>
                <a:gs pos="100000">
                  <a:schemeClr val="dk1">
                    <a:tint val="88500"/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/>
          </c:spPr>
          <c:invertIfNegative val="0"/>
          <c:cat>
            <c:strRef>
              <c:f>'Sheet1 (2)'!$A$2:$T$2</c:f>
              <c:strCache>
                <c:ptCount val="20"/>
                <c:pt idx="0">
                  <c:v>A</c:v>
                </c:pt>
                <c:pt idx="1">
                  <c:v>C</c:v>
                </c:pt>
                <c:pt idx="2">
                  <c:v>D</c:v>
                </c:pt>
                <c:pt idx="3">
                  <c:v>E</c:v>
                </c:pt>
                <c:pt idx="4">
                  <c:v>F</c:v>
                </c:pt>
                <c:pt idx="5">
                  <c:v>G</c:v>
                </c:pt>
                <c:pt idx="6">
                  <c:v>H</c:v>
                </c:pt>
                <c:pt idx="7">
                  <c:v>I</c:v>
                </c:pt>
                <c:pt idx="8">
                  <c:v>K</c:v>
                </c:pt>
                <c:pt idx="9">
                  <c:v>L</c:v>
                </c:pt>
                <c:pt idx="10">
                  <c:v>M</c:v>
                </c:pt>
                <c:pt idx="11">
                  <c:v>N</c:v>
                </c:pt>
                <c:pt idx="12">
                  <c:v>P</c:v>
                </c:pt>
                <c:pt idx="13">
                  <c:v>Q</c:v>
                </c:pt>
                <c:pt idx="14">
                  <c:v>R</c:v>
                </c:pt>
                <c:pt idx="15">
                  <c:v>S</c:v>
                </c:pt>
                <c:pt idx="16">
                  <c:v>T</c:v>
                </c:pt>
                <c:pt idx="17">
                  <c:v>V</c:v>
                </c:pt>
                <c:pt idx="18">
                  <c:v>W</c:v>
                </c:pt>
                <c:pt idx="19">
                  <c:v>Y</c:v>
                </c:pt>
              </c:strCache>
            </c:strRef>
          </c:cat>
          <c:val>
            <c:numRef>
              <c:f>'Sheet1 (2)'!$A$5:$T$5</c:f>
              <c:numCache>
                <c:formatCode>General</c:formatCode>
                <c:ptCount val="20"/>
                <c:pt idx="0">
                  <c:v>-2.7942399999999998</c:v>
                </c:pt>
                <c:pt idx="1">
                  <c:v>-2.1834799999999999</c:v>
                </c:pt>
                <c:pt idx="2">
                  <c:v>-4.9525399999999999</c:v>
                </c:pt>
                <c:pt idx="3">
                  <c:v>4.5789999999999997E-2</c:v>
                </c:pt>
                <c:pt idx="4">
                  <c:v>0.64912999999999998</c:v>
                </c:pt>
                <c:pt idx="5">
                  <c:v>-1.49454</c:v>
                </c:pt>
                <c:pt idx="6">
                  <c:v>-2.1580900000000001</c:v>
                </c:pt>
                <c:pt idx="7">
                  <c:v>-0.72296000000000005</c:v>
                </c:pt>
                <c:pt idx="8">
                  <c:v>-3.4477199999999999</c:v>
                </c:pt>
                <c:pt idx="9">
                  <c:v>-0.70404999999999995</c:v>
                </c:pt>
                <c:pt idx="10">
                  <c:v>-2.6342599999999998</c:v>
                </c:pt>
                <c:pt idx="11">
                  <c:v>-2.8635600000000001</c:v>
                </c:pt>
                <c:pt idx="12">
                  <c:v>1.7089099999999999</c:v>
                </c:pt>
                <c:pt idx="13">
                  <c:v>2.2987799999999998</c:v>
                </c:pt>
                <c:pt idx="14">
                  <c:v>-2.25379</c:v>
                </c:pt>
                <c:pt idx="15">
                  <c:v>-0.64405999999999997</c:v>
                </c:pt>
                <c:pt idx="16">
                  <c:v>-1.6753100000000001</c:v>
                </c:pt>
                <c:pt idx="17">
                  <c:v>-1.88618</c:v>
                </c:pt>
                <c:pt idx="18">
                  <c:v>-1.38276</c:v>
                </c:pt>
                <c:pt idx="19">
                  <c:v>-0.29713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19-4AA4-A2A1-6610A68F02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470615480"/>
        <c:axId val="470613840"/>
      </c:barChart>
      <c:catAx>
        <c:axId val="470615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0613840"/>
        <c:crosses val="autoZero"/>
        <c:auto val="1"/>
        <c:lblAlgn val="ctr"/>
        <c:lblOffset val="100"/>
        <c:noMultiLvlLbl val="0"/>
      </c:catAx>
      <c:valAx>
        <c:axId val="470613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cap="all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log (f[celiac]/f[background]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cap="all" baseline="0">
                  <a:solidFill>
                    <a:schemeClr val="tx1">
                      <a:lumMod val="50000"/>
                      <a:lumOff val="50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06154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cap="none" spc="2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SG" sz="1800" dirty="0"/>
              <a:t>Average Celiac fingerprint score </a:t>
            </a:r>
            <a:r>
              <a:rPr lang="en-SG" sz="1600" dirty="0"/>
              <a:t>(highest window of 9AA)</a:t>
            </a:r>
            <a:endParaRPr lang="en-SG" sz="18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rotWithShape="1">
              <a:gsLst>
                <a:gs pos="0">
                  <a:schemeClr val="accent3">
                    <a:lumMod val="110000"/>
                    <a:satMod val="105000"/>
                    <a:tint val="67000"/>
                  </a:schemeClr>
                </a:gs>
                <a:gs pos="50000">
                  <a:schemeClr val="accent3">
                    <a:lumMod val="105000"/>
                    <a:satMod val="103000"/>
                    <a:tint val="73000"/>
                  </a:schemeClr>
                </a:gs>
                <a:gs pos="100000">
                  <a:schemeClr val="accent3"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accent3">
                  <a:shade val="95000"/>
                </a:schemeClr>
              </a:solidFill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win9'!$N$2:$N$3</c:f>
                <c:numCache>
                  <c:formatCode>General</c:formatCode>
                  <c:ptCount val="2"/>
                  <c:pt idx="0">
                    <c:v>3.7294998662903489</c:v>
                  </c:pt>
                  <c:pt idx="1">
                    <c:v>4.4786853383727125</c:v>
                  </c:pt>
                </c:numCache>
              </c:numRef>
            </c:plus>
            <c:minus>
              <c:numRef>
                <c:f>'win9'!$N$2:$N$3</c:f>
                <c:numCache>
                  <c:formatCode>General</c:formatCode>
                  <c:ptCount val="2"/>
                  <c:pt idx="0">
                    <c:v>3.7294998662903489</c:v>
                  </c:pt>
                  <c:pt idx="1">
                    <c:v>4.4786853383727125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win9'!$L$2:$L$3</c:f>
              <c:strCache>
                <c:ptCount val="2"/>
                <c:pt idx="0">
                  <c:v>farrp celiac peptides</c:v>
                </c:pt>
                <c:pt idx="1">
                  <c:v>human proteins</c:v>
                </c:pt>
              </c:strCache>
            </c:strRef>
          </c:cat>
          <c:val>
            <c:numRef>
              <c:f>'win9'!$M$2:$M$3</c:f>
              <c:numCache>
                <c:formatCode>General</c:formatCode>
                <c:ptCount val="2"/>
                <c:pt idx="0">
                  <c:v>13.778887005254003</c:v>
                </c:pt>
                <c:pt idx="1">
                  <c:v>1.93776563164063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F9-44C4-9878-3AC1432400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623064968"/>
        <c:axId val="623065296"/>
      </c:barChart>
      <c:catAx>
        <c:axId val="623064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3065296"/>
        <c:crosses val="autoZero"/>
        <c:auto val="1"/>
        <c:lblAlgn val="ctr"/>
        <c:lblOffset val="100"/>
        <c:noMultiLvlLbl val="0"/>
      </c:catAx>
      <c:valAx>
        <c:axId val="6230652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3064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SG" dirty="0"/>
              <a:t>Sensitivity for 4180 known allergens - Cross-Valida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4</c:f>
              <c:strCache>
                <c:ptCount val="1"/>
                <c:pt idx="0">
                  <c:v>strong evidenc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Sheet1!$D$3:$F$3</c:f>
              <c:strCache>
                <c:ptCount val="3"/>
                <c:pt idx="0">
                  <c:v>AllerCatPro no CV</c:v>
                </c:pt>
                <c:pt idx="1">
                  <c:v>AllerCatPro CV 100%</c:v>
                </c:pt>
                <c:pt idx="2">
                  <c:v>AllerCatPro CV 90%</c:v>
                </c:pt>
              </c:strCache>
            </c:strRef>
          </c:cat>
          <c:val>
            <c:numRef>
              <c:f>Sheet1!$D$4:$F$4</c:f>
              <c:numCache>
                <c:formatCode>General</c:formatCode>
                <c:ptCount val="3"/>
                <c:pt idx="0">
                  <c:v>99.6</c:v>
                </c:pt>
                <c:pt idx="1">
                  <c:v>90.2</c:v>
                </c:pt>
                <c:pt idx="2">
                  <c:v>76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07-4BBE-B292-BFBBDFF97EB8}"/>
            </c:ext>
          </c:extLst>
        </c:ser>
        <c:ser>
          <c:idx val="1"/>
          <c:order val="1"/>
          <c:tx>
            <c:strRef>
              <c:f>Sheet1!$B$5</c:f>
              <c:strCache>
                <c:ptCount val="1"/>
                <c:pt idx="0">
                  <c:v>weak evidence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D$3:$F$3</c:f>
              <c:strCache>
                <c:ptCount val="3"/>
                <c:pt idx="0">
                  <c:v>AllerCatPro no CV</c:v>
                </c:pt>
                <c:pt idx="1">
                  <c:v>AllerCatPro CV 100%</c:v>
                </c:pt>
                <c:pt idx="2">
                  <c:v>AllerCatPro CV 90%</c:v>
                </c:pt>
              </c:strCache>
            </c:strRef>
          </c:cat>
          <c:val>
            <c:numRef>
              <c:f>Sheet1!$D$5:$F$5</c:f>
              <c:numCache>
                <c:formatCode>General</c:formatCode>
                <c:ptCount val="3"/>
                <c:pt idx="0">
                  <c:v>0.3</c:v>
                </c:pt>
                <c:pt idx="1">
                  <c:v>7</c:v>
                </c:pt>
                <c:pt idx="2">
                  <c:v>17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007-4BBE-B292-BFBBDFF97EB8}"/>
            </c:ext>
          </c:extLst>
        </c:ser>
        <c:ser>
          <c:idx val="2"/>
          <c:order val="2"/>
          <c:tx>
            <c:strRef>
              <c:f>Sheet1!$B$6</c:f>
              <c:strCache>
                <c:ptCount val="1"/>
                <c:pt idx="0">
                  <c:v>no evidence</c:v>
                </c:pt>
              </c:strCache>
            </c:strRef>
          </c:tx>
          <c:spPr>
            <a:solidFill>
              <a:srgbClr val="006600"/>
            </a:solidFill>
            <a:ln>
              <a:noFill/>
            </a:ln>
            <a:effectLst/>
          </c:spPr>
          <c:invertIfNegative val="0"/>
          <c:cat>
            <c:strRef>
              <c:f>Sheet1!$D$3:$F$3</c:f>
              <c:strCache>
                <c:ptCount val="3"/>
                <c:pt idx="0">
                  <c:v>AllerCatPro no CV</c:v>
                </c:pt>
                <c:pt idx="1">
                  <c:v>AllerCatPro CV 100%</c:v>
                </c:pt>
                <c:pt idx="2">
                  <c:v>AllerCatPro CV 90%</c:v>
                </c:pt>
              </c:strCache>
            </c:strRef>
          </c:cat>
          <c:val>
            <c:numRef>
              <c:f>Sheet1!$D$6:$F$6</c:f>
              <c:numCache>
                <c:formatCode>General</c:formatCode>
                <c:ptCount val="3"/>
                <c:pt idx="0">
                  <c:v>0.1</c:v>
                </c:pt>
                <c:pt idx="1">
                  <c:v>2.8</c:v>
                </c:pt>
                <c:pt idx="2">
                  <c:v>6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007-4BBE-B292-BFBBDFF97E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012072"/>
        <c:axId val="423013056"/>
      </c:barChart>
      <c:catAx>
        <c:axId val="423012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013056"/>
        <c:crosses val="autoZero"/>
        <c:auto val="1"/>
        <c:lblAlgn val="ctr"/>
        <c:lblOffset val="100"/>
        <c:noMultiLvlLbl val="0"/>
      </c:catAx>
      <c:valAx>
        <c:axId val="423013056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predicte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0120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/>
      </a:pPr>
      <a:endParaRPr lang="en-US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SG"/>
              <a:t>Sensitivity for known allergens - other dataset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4</c:f>
              <c:strCache>
                <c:ptCount val="1"/>
                <c:pt idx="0">
                  <c:v>strong evidenc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Sheet1!$U$3:$X$3</c:f>
              <c:strCache>
                <c:ptCount val="4"/>
                <c:pt idx="0">
                  <c:v>AllergenFP/AllerTop</c:v>
                </c:pt>
                <c:pt idx="1">
                  <c:v>AllerHunter training</c:v>
                </c:pt>
                <c:pt idx="2">
                  <c:v>AllerHunter test</c:v>
                </c:pt>
                <c:pt idx="3">
                  <c:v>AllerHunter Independent</c:v>
                </c:pt>
              </c:strCache>
            </c:strRef>
          </c:cat>
          <c:val>
            <c:numRef>
              <c:f>Sheet1!$U$4:$X$4</c:f>
              <c:numCache>
                <c:formatCode>General</c:formatCode>
                <c:ptCount val="4"/>
                <c:pt idx="0">
                  <c:v>91.4</c:v>
                </c:pt>
                <c:pt idx="1">
                  <c:v>92.4</c:v>
                </c:pt>
                <c:pt idx="2">
                  <c:v>93.6</c:v>
                </c:pt>
                <c:pt idx="3">
                  <c:v>96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06-40F7-A45E-4DDEBAA5CFFE}"/>
            </c:ext>
          </c:extLst>
        </c:ser>
        <c:ser>
          <c:idx val="1"/>
          <c:order val="1"/>
          <c:tx>
            <c:strRef>
              <c:f>Sheet1!$B$5</c:f>
              <c:strCache>
                <c:ptCount val="1"/>
                <c:pt idx="0">
                  <c:v>weak evidence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U$3:$X$3</c:f>
              <c:strCache>
                <c:ptCount val="4"/>
                <c:pt idx="0">
                  <c:v>AllergenFP/AllerTop</c:v>
                </c:pt>
                <c:pt idx="1">
                  <c:v>AllerHunter training</c:v>
                </c:pt>
                <c:pt idx="2">
                  <c:v>AllerHunter test</c:v>
                </c:pt>
                <c:pt idx="3">
                  <c:v>AllerHunter Independent</c:v>
                </c:pt>
              </c:strCache>
            </c:strRef>
          </c:cat>
          <c:val>
            <c:numRef>
              <c:f>Sheet1!$U$5:$X$5</c:f>
              <c:numCache>
                <c:formatCode>General</c:formatCode>
                <c:ptCount val="4"/>
                <c:pt idx="0">
                  <c:v>5.0999999999999996</c:v>
                </c:pt>
                <c:pt idx="1">
                  <c:v>5.4</c:v>
                </c:pt>
                <c:pt idx="2">
                  <c:v>5</c:v>
                </c:pt>
                <c:pt idx="3">
                  <c:v>2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606-40F7-A45E-4DDEBAA5CFFE}"/>
            </c:ext>
          </c:extLst>
        </c:ser>
        <c:ser>
          <c:idx val="2"/>
          <c:order val="2"/>
          <c:tx>
            <c:strRef>
              <c:f>Sheet1!$B$6</c:f>
              <c:strCache>
                <c:ptCount val="1"/>
                <c:pt idx="0">
                  <c:v>no evidence</c:v>
                </c:pt>
              </c:strCache>
            </c:strRef>
          </c:tx>
          <c:spPr>
            <a:solidFill>
              <a:srgbClr val="006600"/>
            </a:solidFill>
            <a:ln>
              <a:noFill/>
            </a:ln>
            <a:effectLst/>
          </c:spPr>
          <c:invertIfNegative val="0"/>
          <c:cat>
            <c:strRef>
              <c:f>Sheet1!$U$3:$X$3</c:f>
              <c:strCache>
                <c:ptCount val="4"/>
                <c:pt idx="0">
                  <c:v>AllergenFP/AllerTop</c:v>
                </c:pt>
                <c:pt idx="1">
                  <c:v>AllerHunter training</c:v>
                </c:pt>
                <c:pt idx="2">
                  <c:v>AllerHunter test</c:v>
                </c:pt>
                <c:pt idx="3">
                  <c:v>AllerHunter Independent</c:v>
                </c:pt>
              </c:strCache>
            </c:strRef>
          </c:cat>
          <c:val>
            <c:numRef>
              <c:f>Sheet1!$U$6:$X$6</c:f>
              <c:numCache>
                <c:formatCode>General</c:formatCode>
                <c:ptCount val="4"/>
                <c:pt idx="0">
                  <c:v>3.5</c:v>
                </c:pt>
                <c:pt idx="1">
                  <c:v>2.2000000000000002</c:v>
                </c:pt>
                <c:pt idx="2">
                  <c:v>1.4</c:v>
                </c:pt>
                <c:pt idx="3">
                  <c:v>0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606-40F7-A45E-4DDEBAA5CF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012072"/>
        <c:axId val="423013056"/>
      </c:barChart>
      <c:catAx>
        <c:axId val="423012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013056"/>
        <c:crosses val="autoZero"/>
        <c:auto val="1"/>
        <c:lblAlgn val="ctr"/>
        <c:lblOffset val="100"/>
        <c:noMultiLvlLbl val="0"/>
      </c:catAx>
      <c:valAx>
        <c:axId val="423013056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predicte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0120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/>
      </a:pPr>
      <a:endParaRPr lang="en-US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SG" sz="1800"/>
              <a:t>Performance benchmark </a:t>
            </a:r>
          </a:p>
          <a:p>
            <a:pPr>
              <a:defRPr/>
            </a:pPr>
            <a:r>
              <a:rPr lang="en-SG" sz="1200"/>
              <a:t>(allergens vs non-allergens with same structure fold)</a:t>
            </a:r>
          </a:p>
        </c:rich>
      </c:tx>
      <c:layout>
        <c:manualLayout>
          <c:xMode val="edge"/>
          <c:yMode val="edge"/>
          <c:x val="0.26551121216011664"/>
          <c:y val="2.111976647516904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chemeClr val="tx1">
                  <a:lumMod val="95000"/>
                  <a:lumOff val="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dPt>
            <c:idx val="5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accent3"/>
                </a:solidFill>
              </a:ln>
              <a:effectLst>
                <a:outerShdw blurRad="40000" dist="20000" dir="5400000" rotWithShape="0">
                  <a:srgbClr val="000000">
                    <a:alpha val="38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AC2F-4801-9058-3B9C68BA07F3}"/>
              </c:ext>
            </c:extLst>
          </c:dPt>
          <c:cat>
            <c:strRef>
              <c:f>'15.8 2018 221'!$C$1:$H$1</c:f>
              <c:strCache>
                <c:ptCount val="6"/>
                <c:pt idx="0">
                  <c:v>2001 (FAO/WHO)</c:v>
                </c:pt>
                <c:pt idx="1">
                  <c:v>PREAL</c:v>
                </c:pt>
                <c:pt idx="2">
                  <c:v>AllerHunter</c:v>
                </c:pt>
                <c:pt idx="3">
                  <c:v>AllergenFP</c:v>
                </c:pt>
                <c:pt idx="4">
                  <c:v>AllerTOPv2</c:v>
                </c:pt>
                <c:pt idx="5">
                  <c:v>AllerCatPro</c:v>
                </c:pt>
              </c:strCache>
            </c:strRef>
          </c:cat>
          <c:val>
            <c:numRef>
              <c:f>'15.8 2018 221'!$C$11:$H$11</c:f>
              <c:numCache>
                <c:formatCode>0.000</c:formatCode>
                <c:ptCount val="6"/>
                <c:pt idx="0">
                  <c:v>0</c:v>
                </c:pt>
                <c:pt idx="1">
                  <c:v>0.14518704881564082</c:v>
                </c:pt>
                <c:pt idx="2">
                  <c:v>0.25972220024821746</c:v>
                </c:pt>
                <c:pt idx="3">
                  <c:v>0.38711507725536187</c:v>
                </c:pt>
                <c:pt idx="4">
                  <c:v>0.4710463753916303</c:v>
                </c:pt>
                <c:pt idx="5">
                  <c:v>0.713114593321572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C2F-4801-9058-3B9C68BA07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80423936"/>
        <c:axId val="87762624"/>
      </c:barChart>
      <c:catAx>
        <c:axId val="804239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762624"/>
        <c:crosses val="autoZero"/>
        <c:auto val="1"/>
        <c:lblAlgn val="ctr"/>
        <c:lblOffset val="100"/>
        <c:noMultiLvlLbl val="0"/>
      </c:catAx>
      <c:valAx>
        <c:axId val="877626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olid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Matthew Correlation Coefficient</a:t>
                </a:r>
              </a:p>
            </c:rich>
          </c:tx>
          <c:layout>
            <c:manualLayout>
              <c:xMode val="edge"/>
              <c:yMode val="edge"/>
              <c:x val="9.70818989112264E-3"/>
              <c:y val="0.3399961862963509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95000"/>
                      <a:lumOff val="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0" sourceLinked="1"/>
        <c:majorTickMark val="none"/>
        <c:minorTickMark val="none"/>
        <c:tickLblPos val="nextTo"/>
        <c:spPr>
          <a:noFill/>
          <a:ln w="9525" cap="flat" cmpd="sng" algn="ctr">
            <a:noFill/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04239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>
          <a:solidFill>
            <a:schemeClr val="tx1">
              <a:lumMod val="95000"/>
              <a:lumOff val="5000"/>
            </a:schemeClr>
          </a:solidFill>
        </a:defRPr>
      </a:pPr>
      <a:endParaRPr lang="en-US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SG"/>
              <a:t>SCOP fold distribu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All alpha protein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C$1:$E$1</c:f>
              <c:strCache>
                <c:ptCount val="3"/>
                <c:pt idx="0">
                  <c:v>AllerCatPro (3D+models)</c:v>
                </c:pt>
                <c:pt idx="1">
                  <c:v>Dall'Antonia</c:v>
                </c:pt>
                <c:pt idx="2">
                  <c:v>SDAP (3D)</c:v>
                </c:pt>
              </c:strCache>
            </c:strRef>
          </c:cat>
          <c:val>
            <c:numRef>
              <c:f>Sheet1!$C$2:$E$2</c:f>
              <c:numCache>
                <c:formatCode>General</c:formatCode>
                <c:ptCount val="3"/>
                <c:pt idx="0">
                  <c:v>53</c:v>
                </c:pt>
                <c:pt idx="1">
                  <c:v>14</c:v>
                </c:pt>
                <c:pt idx="2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567-4379-9418-A8EAD48F02BE}"/>
            </c:ext>
          </c:extLst>
        </c:ser>
        <c:ser>
          <c:idx val="1"/>
          <c:order val="1"/>
          <c:tx>
            <c:strRef>
              <c:f>Sheet1!$B$3</c:f>
              <c:strCache>
                <c:ptCount val="1"/>
                <c:pt idx="0">
                  <c:v>All beta protein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C$1:$E$1</c:f>
              <c:strCache>
                <c:ptCount val="3"/>
                <c:pt idx="0">
                  <c:v>AllerCatPro (3D+models)</c:v>
                </c:pt>
                <c:pt idx="1">
                  <c:v>Dall'Antonia</c:v>
                </c:pt>
                <c:pt idx="2">
                  <c:v>SDAP (3D)</c:v>
                </c:pt>
              </c:strCache>
            </c:strRef>
          </c:cat>
          <c:val>
            <c:numRef>
              <c:f>Sheet1!$C$3:$E$3</c:f>
              <c:numCache>
                <c:formatCode>General</c:formatCode>
                <c:ptCount val="3"/>
                <c:pt idx="0">
                  <c:v>71</c:v>
                </c:pt>
                <c:pt idx="1">
                  <c:v>15</c:v>
                </c:pt>
                <c:pt idx="2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567-4379-9418-A8EAD48F02BE}"/>
            </c:ext>
          </c:extLst>
        </c:ser>
        <c:ser>
          <c:idx val="2"/>
          <c:order val="2"/>
          <c:tx>
            <c:strRef>
              <c:f>Sheet1!$B$4</c:f>
              <c:strCache>
                <c:ptCount val="1"/>
                <c:pt idx="0">
                  <c:v>Alpha and beta proteins (a/b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C$1:$E$1</c:f>
              <c:strCache>
                <c:ptCount val="3"/>
                <c:pt idx="0">
                  <c:v>AllerCatPro (3D+models)</c:v>
                </c:pt>
                <c:pt idx="1">
                  <c:v>Dall'Antonia</c:v>
                </c:pt>
                <c:pt idx="2">
                  <c:v>SDAP (3D)</c:v>
                </c:pt>
              </c:strCache>
            </c:strRef>
          </c:cat>
          <c:val>
            <c:numRef>
              <c:f>Sheet1!$C$4:$E$4</c:f>
              <c:numCache>
                <c:formatCode>General</c:formatCode>
                <c:ptCount val="3"/>
                <c:pt idx="0">
                  <c:v>58</c:v>
                </c:pt>
                <c:pt idx="1">
                  <c:v>5</c:v>
                </c:pt>
                <c:pt idx="2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567-4379-9418-A8EAD48F02BE}"/>
            </c:ext>
          </c:extLst>
        </c:ser>
        <c:ser>
          <c:idx val="3"/>
          <c:order val="3"/>
          <c:tx>
            <c:strRef>
              <c:f>Sheet1!$B$5</c:f>
              <c:strCache>
                <c:ptCount val="1"/>
                <c:pt idx="0">
                  <c:v>Alpha and beta proteins (a+b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C$1:$E$1</c:f>
              <c:strCache>
                <c:ptCount val="3"/>
                <c:pt idx="0">
                  <c:v>AllerCatPro (3D+models)</c:v>
                </c:pt>
                <c:pt idx="1">
                  <c:v>Dall'Antonia</c:v>
                </c:pt>
                <c:pt idx="2">
                  <c:v>SDAP (3D)</c:v>
                </c:pt>
              </c:strCache>
            </c:strRef>
          </c:cat>
          <c:val>
            <c:numRef>
              <c:f>Sheet1!$C$5:$E$5</c:f>
              <c:numCache>
                <c:formatCode>General</c:formatCode>
                <c:ptCount val="3"/>
                <c:pt idx="0">
                  <c:v>58</c:v>
                </c:pt>
                <c:pt idx="1">
                  <c:v>8</c:v>
                </c:pt>
                <c:pt idx="2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567-4379-9418-A8EAD48F02BE}"/>
            </c:ext>
          </c:extLst>
        </c:ser>
        <c:ser>
          <c:idx val="4"/>
          <c:order val="4"/>
          <c:tx>
            <c:strRef>
              <c:f>Sheet1!$B$6</c:f>
              <c:strCache>
                <c:ptCount val="1"/>
                <c:pt idx="0">
                  <c:v>Membrane and cell surface protein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1!$C$1:$E$1</c:f>
              <c:strCache>
                <c:ptCount val="3"/>
                <c:pt idx="0">
                  <c:v>AllerCatPro (3D+models)</c:v>
                </c:pt>
                <c:pt idx="1">
                  <c:v>Dall'Antonia</c:v>
                </c:pt>
                <c:pt idx="2">
                  <c:v>SDAP (3D)</c:v>
                </c:pt>
              </c:strCache>
            </c:strRef>
          </c:cat>
          <c:val>
            <c:numRef>
              <c:f>Sheet1!$C$6:$E$6</c:f>
              <c:numCache>
                <c:formatCode>General</c:formatCode>
                <c:ptCount val="3"/>
                <c:pt idx="0">
                  <c:v>4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567-4379-9418-A8EAD48F02BE}"/>
            </c:ext>
          </c:extLst>
        </c:ser>
        <c:ser>
          <c:idx val="5"/>
          <c:order val="5"/>
          <c:tx>
            <c:strRef>
              <c:f>Sheet1!$B$7</c:f>
              <c:strCache>
                <c:ptCount val="1"/>
                <c:pt idx="0">
                  <c:v>Multi-domain proteins (alpha and beta)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1!$C$1:$E$1</c:f>
              <c:strCache>
                <c:ptCount val="3"/>
                <c:pt idx="0">
                  <c:v>AllerCatPro (3D+models)</c:v>
                </c:pt>
                <c:pt idx="1">
                  <c:v>Dall'Antonia</c:v>
                </c:pt>
                <c:pt idx="2">
                  <c:v>SDAP (3D)</c:v>
                </c:pt>
              </c:strCache>
            </c:strRef>
          </c:cat>
          <c:val>
            <c:numRef>
              <c:f>Sheet1!$C$7:$E$7</c:f>
              <c:numCache>
                <c:formatCode>General</c:formatCode>
                <c:ptCount val="3"/>
                <c:pt idx="0">
                  <c:v>1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567-4379-9418-A8EAD48F02BE}"/>
            </c:ext>
          </c:extLst>
        </c:ser>
        <c:ser>
          <c:idx val="6"/>
          <c:order val="6"/>
          <c:tx>
            <c:strRef>
              <c:f>Sheet1!$B$8</c:f>
              <c:strCache>
                <c:ptCount val="1"/>
                <c:pt idx="0">
                  <c:v>Small proteins and peptides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C$1:$E$1</c:f>
              <c:strCache>
                <c:ptCount val="3"/>
                <c:pt idx="0">
                  <c:v>AllerCatPro (3D+models)</c:v>
                </c:pt>
                <c:pt idx="1">
                  <c:v>Dall'Antonia</c:v>
                </c:pt>
                <c:pt idx="2">
                  <c:v>SDAP (3D)</c:v>
                </c:pt>
              </c:strCache>
            </c:strRef>
          </c:cat>
          <c:val>
            <c:numRef>
              <c:f>Sheet1!$C$8:$E$8</c:f>
              <c:numCache>
                <c:formatCode>General</c:formatCode>
                <c:ptCount val="3"/>
                <c:pt idx="0">
                  <c:v>3</c:v>
                </c:pt>
                <c:pt idx="1">
                  <c:v>5</c:v>
                </c:pt>
                <c:pt idx="2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567-4379-9418-A8EAD48F02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40763568"/>
        <c:axId val="440761928"/>
      </c:barChart>
      <c:catAx>
        <c:axId val="440763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0761928"/>
        <c:crosses val="autoZero"/>
        <c:auto val="1"/>
        <c:lblAlgn val="ctr"/>
        <c:lblOffset val="100"/>
        <c:noMultiLvlLbl val="0"/>
      </c:catAx>
      <c:valAx>
        <c:axId val="4407619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07635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SG"/>
              <a:t>SCOP fold classifica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1</c:f>
              <c:strCache>
                <c:ptCount val="1"/>
                <c:pt idx="0">
                  <c:v>AllerCatPro (3D+models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2:$B$8</c:f>
              <c:strCache>
                <c:ptCount val="7"/>
                <c:pt idx="0">
                  <c:v>All alpha proteins</c:v>
                </c:pt>
                <c:pt idx="1">
                  <c:v>All beta proteins</c:v>
                </c:pt>
                <c:pt idx="2">
                  <c:v>Alpha and beta proteins (a/b)</c:v>
                </c:pt>
                <c:pt idx="3">
                  <c:v>Alpha and beta proteins (a+b)</c:v>
                </c:pt>
                <c:pt idx="4">
                  <c:v>Membrane and cell surface proteins</c:v>
                </c:pt>
                <c:pt idx="5">
                  <c:v>Multi-domain proteins (alpha and beta)</c:v>
                </c:pt>
                <c:pt idx="6">
                  <c:v>Small proteins and peptides</c:v>
                </c:pt>
              </c:strCache>
            </c:strRef>
          </c:cat>
          <c:val>
            <c:numRef>
              <c:f>Sheet1!$C$2:$C$8</c:f>
              <c:numCache>
                <c:formatCode>General</c:formatCode>
                <c:ptCount val="7"/>
                <c:pt idx="0">
                  <c:v>53</c:v>
                </c:pt>
                <c:pt idx="1">
                  <c:v>71</c:v>
                </c:pt>
                <c:pt idx="2">
                  <c:v>58</c:v>
                </c:pt>
                <c:pt idx="3">
                  <c:v>58</c:v>
                </c:pt>
                <c:pt idx="4">
                  <c:v>4</c:v>
                </c:pt>
                <c:pt idx="5">
                  <c:v>1</c:v>
                </c:pt>
                <c:pt idx="6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44D-4724-8C3D-903896C65DA3}"/>
            </c:ext>
          </c:extLst>
        </c:ser>
        <c:ser>
          <c:idx val="1"/>
          <c:order val="1"/>
          <c:tx>
            <c:strRef>
              <c:f>Sheet1!$D$1</c:f>
              <c:strCache>
                <c:ptCount val="1"/>
                <c:pt idx="0">
                  <c:v>Dall'Antoni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2:$B$8</c:f>
              <c:strCache>
                <c:ptCount val="7"/>
                <c:pt idx="0">
                  <c:v>All alpha proteins</c:v>
                </c:pt>
                <c:pt idx="1">
                  <c:v>All beta proteins</c:v>
                </c:pt>
                <c:pt idx="2">
                  <c:v>Alpha and beta proteins (a/b)</c:v>
                </c:pt>
                <c:pt idx="3">
                  <c:v>Alpha and beta proteins (a+b)</c:v>
                </c:pt>
                <c:pt idx="4">
                  <c:v>Membrane and cell surface proteins</c:v>
                </c:pt>
                <c:pt idx="5">
                  <c:v>Multi-domain proteins (alpha and beta)</c:v>
                </c:pt>
                <c:pt idx="6">
                  <c:v>Small proteins and peptides</c:v>
                </c:pt>
              </c:strCache>
            </c:strRef>
          </c:cat>
          <c:val>
            <c:numRef>
              <c:f>Sheet1!$D$2:$D$8</c:f>
              <c:numCache>
                <c:formatCode>General</c:formatCode>
                <c:ptCount val="7"/>
                <c:pt idx="0">
                  <c:v>14</c:v>
                </c:pt>
                <c:pt idx="1">
                  <c:v>15</c:v>
                </c:pt>
                <c:pt idx="2">
                  <c:v>5</c:v>
                </c:pt>
                <c:pt idx="3">
                  <c:v>8</c:v>
                </c:pt>
                <c:pt idx="4">
                  <c:v>0</c:v>
                </c:pt>
                <c:pt idx="5">
                  <c:v>0</c:v>
                </c:pt>
                <c:pt idx="6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44D-4724-8C3D-903896C65DA3}"/>
            </c:ext>
          </c:extLst>
        </c:ser>
        <c:ser>
          <c:idx val="2"/>
          <c:order val="2"/>
          <c:tx>
            <c:strRef>
              <c:f>Sheet1!$E$1</c:f>
              <c:strCache>
                <c:ptCount val="1"/>
                <c:pt idx="0">
                  <c:v>SDAP (3D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B$2:$B$8</c:f>
              <c:strCache>
                <c:ptCount val="7"/>
                <c:pt idx="0">
                  <c:v>All alpha proteins</c:v>
                </c:pt>
                <c:pt idx="1">
                  <c:v>All beta proteins</c:v>
                </c:pt>
                <c:pt idx="2">
                  <c:v>Alpha and beta proteins (a/b)</c:v>
                </c:pt>
                <c:pt idx="3">
                  <c:v>Alpha and beta proteins (a+b)</c:v>
                </c:pt>
                <c:pt idx="4">
                  <c:v>Membrane and cell surface proteins</c:v>
                </c:pt>
                <c:pt idx="5">
                  <c:v>Multi-domain proteins (alpha and beta)</c:v>
                </c:pt>
                <c:pt idx="6">
                  <c:v>Small proteins and peptides</c:v>
                </c:pt>
              </c:strCache>
            </c:strRef>
          </c:cat>
          <c:val>
            <c:numRef>
              <c:f>Sheet1!$E$2:$E$8</c:f>
              <c:numCache>
                <c:formatCode>General</c:formatCode>
                <c:ptCount val="7"/>
                <c:pt idx="0">
                  <c:v>14</c:v>
                </c:pt>
                <c:pt idx="1">
                  <c:v>15</c:v>
                </c:pt>
                <c:pt idx="2">
                  <c:v>5</c:v>
                </c:pt>
                <c:pt idx="3">
                  <c:v>10</c:v>
                </c:pt>
                <c:pt idx="4">
                  <c:v>0</c:v>
                </c:pt>
                <c:pt idx="5">
                  <c:v>0</c:v>
                </c:pt>
                <c:pt idx="6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44D-4724-8C3D-903896C65D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34992688"/>
        <c:axId val="734991704"/>
      </c:barChart>
      <c:catAx>
        <c:axId val="734992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34991704"/>
        <c:crosses val="autoZero"/>
        <c:auto val="1"/>
        <c:lblAlgn val="ctr"/>
        <c:lblOffset val="100"/>
        <c:noMultiLvlLbl val="0"/>
      </c:catAx>
      <c:valAx>
        <c:axId val="7349917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Number of representative structur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349926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4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FA4F-2E00-4E8B-BD27-A8960462BED5}" type="datetimeFigureOut">
              <a:rPr lang="en-SG" smtClean="0"/>
              <a:t>18/12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22ED-8212-4FB4-BAA0-20AE158876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327671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FA4F-2E00-4E8B-BD27-A8960462BED5}" type="datetimeFigureOut">
              <a:rPr lang="en-SG" smtClean="0"/>
              <a:t>18/12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22ED-8212-4FB4-BAA0-20AE158876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810855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FA4F-2E00-4E8B-BD27-A8960462BED5}" type="datetimeFigureOut">
              <a:rPr lang="en-SG" smtClean="0"/>
              <a:t>18/12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22ED-8212-4FB4-BAA0-20AE158876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660386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FA4F-2E00-4E8B-BD27-A8960462BED5}" type="datetimeFigureOut">
              <a:rPr lang="en-SG" smtClean="0"/>
              <a:t>18/12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22ED-8212-4FB4-BAA0-20AE158876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9924670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FA4F-2E00-4E8B-BD27-A8960462BED5}" type="datetimeFigureOut">
              <a:rPr lang="en-SG" smtClean="0"/>
              <a:t>18/12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22ED-8212-4FB4-BAA0-20AE158876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953124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FA4F-2E00-4E8B-BD27-A8960462BED5}" type="datetimeFigureOut">
              <a:rPr lang="en-SG" smtClean="0"/>
              <a:t>18/12/2018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22ED-8212-4FB4-BAA0-20AE158876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3354595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FA4F-2E00-4E8B-BD27-A8960462BED5}" type="datetimeFigureOut">
              <a:rPr lang="en-SG" smtClean="0"/>
              <a:t>18/12/2018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22ED-8212-4FB4-BAA0-20AE158876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0551837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FA4F-2E00-4E8B-BD27-A8960462BED5}" type="datetimeFigureOut">
              <a:rPr lang="en-SG" smtClean="0"/>
              <a:t>18/12/2018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22ED-8212-4FB4-BAA0-20AE158876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3374571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FA4F-2E00-4E8B-BD27-A8960462BED5}" type="datetimeFigureOut">
              <a:rPr lang="en-SG" smtClean="0"/>
              <a:t>18/12/2018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22ED-8212-4FB4-BAA0-20AE158876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736715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FA4F-2E00-4E8B-BD27-A8960462BED5}" type="datetimeFigureOut">
              <a:rPr lang="en-SG" smtClean="0"/>
              <a:t>18/12/2018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22ED-8212-4FB4-BAA0-20AE158876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856724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8FA4F-2E00-4E8B-BD27-A8960462BED5}" type="datetimeFigureOut">
              <a:rPr lang="en-SG" smtClean="0"/>
              <a:t>18/12/2018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22ED-8212-4FB4-BAA0-20AE158876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649587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08FA4F-2E00-4E8B-BD27-A8960462BED5}" type="datetimeFigureOut">
              <a:rPr lang="en-SG" smtClean="0"/>
              <a:t>18/12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EB22ED-8212-4FB4-BAA0-20AE158876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520884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D3E1294-562F-4001-9D3C-C8CAD273DBA9}"/>
              </a:ext>
            </a:extLst>
          </p:cNvPr>
          <p:cNvSpPr txBox="1"/>
          <p:nvPr/>
        </p:nvSpPr>
        <p:spPr>
          <a:xfrm>
            <a:off x="218114" y="6342077"/>
            <a:ext cx="1513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 err="1"/>
              <a:t>Suppl</a:t>
            </a:r>
            <a:r>
              <a:rPr lang="en-SG" dirty="0"/>
              <a:t> Figure 1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C47EBDC0-F886-46E0-8B98-D932001A0F2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138001"/>
              </p:ext>
            </p:extLst>
          </p:nvPr>
        </p:nvGraphicFramePr>
        <p:xfrm>
          <a:off x="1943100" y="1171575"/>
          <a:ext cx="5257800" cy="45148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7244540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6B6B351B-29DA-4FE7-8714-5F6032B593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5904416"/>
              </p:ext>
            </p:extLst>
          </p:nvPr>
        </p:nvGraphicFramePr>
        <p:xfrm>
          <a:off x="322583" y="822121"/>
          <a:ext cx="5256096" cy="51424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9C2C3270-26EF-4BF2-AA56-A94263DAC4B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0682992"/>
              </p:ext>
            </p:extLst>
          </p:nvPr>
        </p:nvGraphicFramePr>
        <p:xfrm>
          <a:off x="5663531" y="587229"/>
          <a:ext cx="2977130" cy="53773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CC4AFB8B-C25A-439D-BC64-D44B8657FB11}"/>
              </a:ext>
            </a:extLst>
          </p:cNvPr>
          <p:cNvSpPr txBox="1"/>
          <p:nvPr/>
        </p:nvSpPr>
        <p:spPr>
          <a:xfrm>
            <a:off x="218114" y="6342077"/>
            <a:ext cx="1513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 err="1"/>
              <a:t>Suppl</a:t>
            </a:r>
            <a:r>
              <a:rPr lang="en-SG" dirty="0"/>
              <a:t> Figure 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3ED573A-7594-4CF4-A8CD-B630CD2EA676}"/>
              </a:ext>
            </a:extLst>
          </p:cNvPr>
          <p:cNvSpPr txBox="1"/>
          <p:nvPr/>
        </p:nvSpPr>
        <p:spPr>
          <a:xfrm>
            <a:off x="322583" y="52409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>
                <a:solidFill>
                  <a:schemeClr val="tx1">
                    <a:lumMod val="95000"/>
                    <a:lumOff val="5000"/>
                  </a:schemeClr>
                </a:solidFill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BABED01-2FA1-441B-A0D9-352FFDD6BC66}"/>
              </a:ext>
            </a:extLst>
          </p:cNvPr>
          <p:cNvSpPr txBox="1"/>
          <p:nvPr/>
        </p:nvSpPr>
        <p:spPr>
          <a:xfrm>
            <a:off x="5578679" y="52409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>
                <a:solidFill>
                  <a:schemeClr val="tx1">
                    <a:lumMod val="95000"/>
                    <a:lumOff val="5000"/>
                  </a:schemeClr>
                </a:solidFill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1981968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CC4AFB8B-C25A-439D-BC64-D44B8657FB11}"/>
              </a:ext>
            </a:extLst>
          </p:cNvPr>
          <p:cNvSpPr txBox="1"/>
          <p:nvPr/>
        </p:nvSpPr>
        <p:spPr>
          <a:xfrm>
            <a:off x="218114" y="6342077"/>
            <a:ext cx="1513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 err="1"/>
              <a:t>Suppl</a:t>
            </a:r>
            <a:r>
              <a:rPr lang="en-SG" dirty="0"/>
              <a:t> Figure 3</a:t>
            </a: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2DDAD394-E4E3-4AD9-812B-BE22C5C7FF8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8451879"/>
              </p:ext>
            </p:extLst>
          </p:nvPr>
        </p:nvGraphicFramePr>
        <p:xfrm>
          <a:off x="1093365" y="1217103"/>
          <a:ext cx="6705600" cy="411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8607486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CC4AFB8B-C25A-439D-BC64-D44B8657FB11}"/>
              </a:ext>
            </a:extLst>
          </p:cNvPr>
          <p:cNvSpPr txBox="1"/>
          <p:nvPr/>
        </p:nvSpPr>
        <p:spPr>
          <a:xfrm>
            <a:off x="218114" y="6342077"/>
            <a:ext cx="1513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 err="1"/>
              <a:t>Suppl</a:t>
            </a:r>
            <a:r>
              <a:rPr lang="en-SG" dirty="0"/>
              <a:t> Figure 4</a:t>
            </a:r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27AC7C01-F087-4F39-A757-F22A2954F7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7949174"/>
              </p:ext>
            </p:extLst>
          </p:nvPr>
        </p:nvGraphicFramePr>
        <p:xfrm>
          <a:off x="1413545" y="1002834"/>
          <a:ext cx="6316909" cy="48523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7838034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CC4AFB8B-C25A-439D-BC64-D44B8657FB11}"/>
              </a:ext>
            </a:extLst>
          </p:cNvPr>
          <p:cNvSpPr txBox="1"/>
          <p:nvPr/>
        </p:nvSpPr>
        <p:spPr>
          <a:xfrm>
            <a:off x="218114" y="6342077"/>
            <a:ext cx="1513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 err="1"/>
              <a:t>Suppl</a:t>
            </a:r>
            <a:r>
              <a:rPr lang="en-SG" dirty="0"/>
              <a:t> Figure 5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ADE66C87-C101-41BC-BB35-A1B094C2B84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5532369"/>
              </p:ext>
            </p:extLst>
          </p:nvPr>
        </p:nvGraphicFramePr>
        <p:xfrm>
          <a:off x="922789" y="721453"/>
          <a:ext cx="6644081" cy="48823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3330505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725F7030-21ED-42E7-942A-3175C87F8A3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3805358"/>
              </p:ext>
            </p:extLst>
          </p:nvPr>
        </p:nvGraphicFramePr>
        <p:xfrm>
          <a:off x="985752" y="173329"/>
          <a:ext cx="6975402" cy="31319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D17FA2D8-F130-4E4F-BC79-96FD659DF5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6812446"/>
              </p:ext>
            </p:extLst>
          </p:nvPr>
        </p:nvGraphicFramePr>
        <p:xfrm>
          <a:off x="847288" y="3305263"/>
          <a:ext cx="7113866" cy="32594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6E5336B2-A2CA-42BD-A9A9-A886AC9027DB}"/>
              </a:ext>
            </a:extLst>
          </p:cNvPr>
          <p:cNvSpPr txBox="1"/>
          <p:nvPr/>
        </p:nvSpPr>
        <p:spPr>
          <a:xfrm>
            <a:off x="218114" y="6342077"/>
            <a:ext cx="1513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 err="1"/>
              <a:t>Suppl</a:t>
            </a:r>
            <a:r>
              <a:rPr lang="en-SG" dirty="0"/>
              <a:t> Figure 6</a:t>
            </a:r>
          </a:p>
        </p:txBody>
      </p:sp>
    </p:spTree>
    <p:extLst>
      <p:ext uri="{BB962C8B-B14F-4D97-AF65-F5344CB8AC3E}">
        <p14:creationId xmlns:p14="http://schemas.microsoft.com/office/powerpoint/2010/main" val="4000898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42A605F-EC90-4240-B21A-D15F2DAA6F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4544" y="1054161"/>
            <a:ext cx="3941415" cy="474967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650FAF7-8C01-4FA1-A184-4DED3722124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3041" y="471137"/>
            <a:ext cx="3817035" cy="564727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05D6D3A-8BA8-46F6-B845-2DDE40BA00FF}"/>
              </a:ext>
            </a:extLst>
          </p:cNvPr>
          <p:cNvSpPr txBox="1"/>
          <p:nvPr/>
        </p:nvSpPr>
        <p:spPr>
          <a:xfrm>
            <a:off x="1314076" y="5905126"/>
            <a:ext cx="30864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G" dirty="0"/>
              <a:t>Rice Bet v 1 epitope used for comparison in </a:t>
            </a:r>
            <a:r>
              <a:rPr lang="en-SG" dirty="0" err="1"/>
              <a:t>AllerCatPro</a:t>
            </a:r>
            <a:endParaRPr lang="en-SG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9E8E24C-AFA9-4D13-96EE-BFE749C5BD30}"/>
              </a:ext>
            </a:extLst>
          </p:cNvPr>
          <p:cNvSpPr txBox="1"/>
          <p:nvPr/>
        </p:nvSpPr>
        <p:spPr>
          <a:xfrm>
            <a:off x="5283200" y="5905125"/>
            <a:ext cx="37147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G" dirty="0"/>
              <a:t>Birch pollen Bet v 1 epitope in complex with </a:t>
            </a:r>
            <a:r>
              <a:rPr lang="en-SG" dirty="0" err="1"/>
              <a:t>IgE</a:t>
            </a:r>
            <a:r>
              <a:rPr lang="en-SG" dirty="0"/>
              <a:t> antibody (PDB:1FSK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892FC4-B000-49DE-AF71-F27E39830276}"/>
              </a:ext>
            </a:extLst>
          </p:cNvPr>
          <p:cNvSpPr txBox="1"/>
          <p:nvPr/>
        </p:nvSpPr>
        <p:spPr>
          <a:xfrm>
            <a:off x="360727" y="201336"/>
            <a:ext cx="1513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 err="1"/>
              <a:t>Suppl</a:t>
            </a:r>
            <a:r>
              <a:rPr lang="en-SG" dirty="0"/>
              <a:t> Figure 7</a:t>
            </a:r>
          </a:p>
        </p:txBody>
      </p:sp>
    </p:spTree>
    <p:extLst>
      <p:ext uri="{BB962C8B-B14F-4D97-AF65-F5344CB8AC3E}">
        <p14:creationId xmlns:p14="http://schemas.microsoft.com/office/powerpoint/2010/main" val="19304547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5</TotalTime>
  <Words>143</Words>
  <Application>Microsoft Office PowerPoint</Application>
  <PresentationFormat>On-screen Show (4:3)</PresentationFormat>
  <Paragraphs>28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bastianms</dc:creator>
  <cp:lastModifiedBy>sebastianms</cp:lastModifiedBy>
  <cp:revision>55</cp:revision>
  <dcterms:created xsi:type="dcterms:W3CDTF">2018-06-04T02:25:37Z</dcterms:created>
  <dcterms:modified xsi:type="dcterms:W3CDTF">2018-12-18T03:49:10Z</dcterms:modified>
</cp:coreProperties>
</file>